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notesSlides/notesSlide2.xml" ContentType="application/vnd.openxmlformats-officedocument.presentationml.notesSl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807" autoAdjust="0"/>
  </p:normalViewPr>
  <p:slideViewPr>
    <p:cSldViewPr>
      <p:cViewPr>
        <p:scale>
          <a:sx n="66" d="100"/>
          <a:sy n="66" d="100"/>
        </p:scale>
        <p:origin x="-824" y="-5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3N2\Interior_nontrunk\NGS_loss\minus_geta\result_cross_table_minus_geta_loss_nontrunk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3N2\Exterior\NGS_stable\minus_geta\result_cross_table_minus_geta_exterior_stable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1N1\Exterior\minus_geta\result_cross_table_NGS_stable_exterior_minus_ge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3N2\Interior_nontrunk\NGS_gain\minus_geta\result_cross_table_minus_ge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1N1\Interior_non_trunk\minus_geta\result_cross_table_NGS_gain_nontrunk_minus_ge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3N2\Interior_nontrunk\NGS_stable\minus_geta\result_cross_table_minus_geta_stable_nontrunk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1N1\Interior_non_trunk\minus_geta\result_cross_table_NGS_stable_nontrunk_minus_get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3N2\Exterior\NGS_gain\minus_geta\result_cross_table_minus_geta_exterior_gain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1N1\Exterior\minus_geta\result_cross_table_NGS_gain_exterior_minus_get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3N2\Exterior\NGS_loss\minus_geta\result_cross_table_minus_geta_exterior_los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istrator\&#12487;&#12473;&#12463;&#12488;&#12483;&#12503;\Charge_results\Substitution_distance_from_RBP\H1N1\Exterior\minus_geta\result_cross_table_NGS_loss_exterior_minus_ge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19:$B$32</c:f>
              <c:numCache>
                <c:formatCode>General</c:formatCode>
                <c:ptCount val="14"/>
                <c:pt idx="0">
                  <c:v>0.096</c:v>
                </c:pt>
                <c:pt idx="1">
                  <c:v>0.424</c:v>
                </c:pt>
                <c:pt idx="2">
                  <c:v>0.2</c:v>
                </c:pt>
                <c:pt idx="3">
                  <c:v>0.12</c:v>
                </c:pt>
                <c:pt idx="4">
                  <c:v>0.12</c:v>
                </c:pt>
                <c:pt idx="5">
                  <c:v>0.04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19:$C$32</c:f>
              <c:numCache>
                <c:formatCode>General</c:formatCode>
                <c:ptCount val="14"/>
                <c:pt idx="0">
                  <c:v>0.0861538461538463</c:v>
                </c:pt>
                <c:pt idx="1">
                  <c:v>0.255384615384616</c:v>
                </c:pt>
                <c:pt idx="2">
                  <c:v>0.212307692307692</c:v>
                </c:pt>
                <c:pt idx="3">
                  <c:v>0.209230769230769</c:v>
                </c:pt>
                <c:pt idx="4">
                  <c:v>0.123076923076923</c:v>
                </c:pt>
                <c:pt idx="5">
                  <c:v>0.036923076923077</c:v>
                </c:pt>
                <c:pt idx="6">
                  <c:v>0.0338461538461538</c:v>
                </c:pt>
                <c:pt idx="7">
                  <c:v>0.0307692307692308</c:v>
                </c:pt>
                <c:pt idx="8">
                  <c:v>0.0123076923076923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8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19:$D$32</c:f>
              <c:numCache>
                <c:formatCode>General</c:formatCode>
                <c:ptCount val="14"/>
                <c:pt idx="0">
                  <c:v>0.113333333333333</c:v>
                </c:pt>
                <c:pt idx="1">
                  <c:v>0.313333333333333</c:v>
                </c:pt>
                <c:pt idx="2">
                  <c:v>0.19</c:v>
                </c:pt>
                <c:pt idx="3">
                  <c:v>0.04</c:v>
                </c:pt>
                <c:pt idx="4">
                  <c:v>0.06</c:v>
                </c:pt>
                <c:pt idx="5">
                  <c:v>0.0333333333333333</c:v>
                </c:pt>
                <c:pt idx="6">
                  <c:v>0.0333333333333333</c:v>
                </c:pt>
                <c:pt idx="7">
                  <c:v>0.0366666666666667</c:v>
                </c:pt>
                <c:pt idx="8">
                  <c:v>0.0133333333333333</c:v>
                </c:pt>
                <c:pt idx="9">
                  <c:v>0.0</c:v>
                </c:pt>
                <c:pt idx="10">
                  <c:v>0.0</c:v>
                </c:pt>
                <c:pt idx="11">
                  <c:v>0.1</c:v>
                </c:pt>
                <c:pt idx="12">
                  <c:v>0.0566666666666667</c:v>
                </c:pt>
                <c:pt idx="13">
                  <c:v>0.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95434808"/>
        <c:axId val="-1994656024"/>
      </c:barChart>
      <c:catAx>
        <c:axId val="-19954348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1994656024"/>
        <c:crosses val="autoZero"/>
        <c:auto val="1"/>
        <c:lblAlgn val="ctr"/>
        <c:lblOffset val="100"/>
        <c:noMultiLvlLbl val="0"/>
      </c:catAx>
      <c:valAx>
        <c:axId val="-1994656024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1995434808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19:$B$32</c:f>
              <c:numCache>
                <c:formatCode>General</c:formatCode>
                <c:ptCount val="14"/>
                <c:pt idx="0">
                  <c:v>0.0942857142857142</c:v>
                </c:pt>
                <c:pt idx="1">
                  <c:v>0.238571428571429</c:v>
                </c:pt>
                <c:pt idx="2">
                  <c:v>0.163809523809524</c:v>
                </c:pt>
                <c:pt idx="3">
                  <c:v>0.154285714285714</c:v>
                </c:pt>
                <c:pt idx="4">
                  <c:v>0.142380952380952</c:v>
                </c:pt>
                <c:pt idx="5">
                  <c:v>0.0719047619047619</c:v>
                </c:pt>
                <c:pt idx="6">
                  <c:v>0.0292857142857143</c:v>
                </c:pt>
                <c:pt idx="7">
                  <c:v>0.0126190476190476</c:v>
                </c:pt>
                <c:pt idx="8">
                  <c:v>0.00357142857142857</c:v>
                </c:pt>
                <c:pt idx="9">
                  <c:v>0.0</c:v>
                </c:pt>
                <c:pt idx="10">
                  <c:v>0.0207142857142857</c:v>
                </c:pt>
                <c:pt idx="11">
                  <c:v>0.0421428571428571</c:v>
                </c:pt>
                <c:pt idx="12">
                  <c:v>0.0264285714285714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19:$C$32</c:f>
              <c:numCache>
                <c:formatCode>General</c:formatCode>
                <c:ptCount val="14"/>
                <c:pt idx="0">
                  <c:v>0.127542857142857</c:v>
                </c:pt>
                <c:pt idx="1">
                  <c:v>0.290057142857143</c:v>
                </c:pt>
                <c:pt idx="2">
                  <c:v>0.142171428571429</c:v>
                </c:pt>
                <c:pt idx="3">
                  <c:v>0.222857142857143</c:v>
                </c:pt>
                <c:pt idx="4">
                  <c:v>0.106971428571429</c:v>
                </c:pt>
                <c:pt idx="5">
                  <c:v>0.0434285714285714</c:v>
                </c:pt>
                <c:pt idx="6">
                  <c:v>0.0128</c:v>
                </c:pt>
                <c:pt idx="7">
                  <c:v>0.00982857142857142</c:v>
                </c:pt>
                <c:pt idx="8">
                  <c:v>0.00434285714285714</c:v>
                </c:pt>
                <c:pt idx="9">
                  <c:v>0.0</c:v>
                </c:pt>
                <c:pt idx="10">
                  <c:v>0.000457142857142857</c:v>
                </c:pt>
                <c:pt idx="11">
                  <c:v>0.0235428571428571</c:v>
                </c:pt>
                <c:pt idx="12">
                  <c:v>0.0157714285714286</c:v>
                </c:pt>
                <c:pt idx="13">
                  <c:v>0.000228571428571429</c:v>
                </c:pt>
              </c:numCache>
            </c:numRef>
          </c:val>
        </c:ser>
        <c:ser>
          <c:idx val="2"/>
          <c:order val="2"/>
          <c:tx>
            <c:strRef>
              <c:f>Sheet1!$D$18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19:$D$32</c:f>
              <c:numCache>
                <c:formatCode>General</c:formatCode>
                <c:ptCount val="14"/>
                <c:pt idx="0">
                  <c:v>0.100559440559441</c:v>
                </c:pt>
                <c:pt idx="1">
                  <c:v>0.245174825174825</c:v>
                </c:pt>
                <c:pt idx="2">
                  <c:v>0.227062937062937</c:v>
                </c:pt>
                <c:pt idx="3">
                  <c:v>0.146573426573427</c:v>
                </c:pt>
                <c:pt idx="4">
                  <c:v>0.100769230769231</c:v>
                </c:pt>
                <c:pt idx="5">
                  <c:v>0.0585314685314685</c:v>
                </c:pt>
                <c:pt idx="6">
                  <c:v>0.0267832167832168</c:v>
                </c:pt>
                <c:pt idx="7">
                  <c:v>0.0186713286713287</c:v>
                </c:pt>
                <c:pt idx="8">
                  <c:v>0.0116083916083916</c:v>
                </c:pt>
                <c:pt idx="9">
                  <c:v>0.00713286713286714</c:v>
                </c:pt>
                <c:pt idx="10">
                  <c:v>0.00902097902097902</c:v>
                </c:pt>
                <c:pt idx="11">
                  <c:v>0.0293706293706294</c:v>
                </c:pt>
                <c:pt idx="12">
                  <c:v>0.0153146853146853</c:v>
                </c:pt>
                <c:pt idx="13">
                  <c:v>0.003426573426573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0707912"/>
        <c:axId val="-2061087928"/>
      </c:barChart>
      <c:catAx>
        <c:axId val="-206070791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1087928"/>
        <c:crosses val="autoZero"/>
        <c:auto val="1"/>
        <c:lblAlgn val="ctr"/>
        <c:lblOffset val="100"/>
        <c:noMultiLvlLbl val="0"/>
      </c:catAx>
      <c:valAx>
        <c:axId val="-2061087928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070791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200533661740558</c:v>
                </c:pt>
                <c:pt idx="1">
                  <c:v>0.386494252873563</c:v>
                </c:pt>
                <c:pt idx="2">
                  <c:v>0.175697865353038</c:v>
                </c:pt>
                <c:pt idx="3">
                  <c:v>0.135057471264368</c:v>
                </c:pt>
                <c:pt idx="4">
                  <c:v>0.054392446633826</c:v>
                </c:pt>
                <c:pt idx="5">
                  <c:v>0.0303776683087028</c:v>
                </c:pt>
                <c:pt idx="6">
                  <c:v>0.0100574712643678</c:v>
                </c:pt>
                <c:pt idx="7">
                  <c:v>0.00102627257799672</c:v>
                </c:pt>
                <c:pt idx="8">
                  <c:v>0.0014367816091954</c:v>
                </c:pt>
                <c:pt idx="9">
                  <c:v>0.00102627257799672</c:v>
                </c:pt>
                <c:pt idx="10">
                  <c:v>0.00184729064039409</c:v>
                </c:pt>
                <c:pt idx="11">
                  <c:v>0.00205254515599343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0932971014492753</c:v>
                </c:pt>
                <c:pt idx="1">
                  <c:v>0.246376811594203</c:v>
                </c:pt>
                <c:pt idx="2">
                  <c:v>0.249094202898551</c:v>
                </c:pt>
                <c:pt idx="3">
                  <c:v>0.173913043478261</c:v>
                </c:pt>
                <c:pt idx="4">
                  <c:v>0.146739130434783</c:v>
                </c:pt>
                <c:pt idx="5">
                  <c:v>0.0625</c:v>
                </c:pt>
                <c:pt idx="6">
                  <c:v>0.0280797101449276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0701530612244898</c:v>
                </c:pt>
                <c:pt idx="1">
                  <c:v>0.219954648526077</c:v>
                </c:pt>
                <c:pt idx="2">
                  <c:v>0.251417233560091</c:v>
                </c:pt>
                <c:pt idx="3">
                  <c:v>0.180130385487529</c:v>
                </c:pt>
                <c:pt idx="4">
                  <c:v>0.0999149659863947</c:v>
                </c:pt>
                <c:pt idx="5">
                  <c:v>0.0609410430839002</c:v>
                </c:pt>
                <c:pt idx="6">
                  <c:v>0.0408163265306123</c:v>
                </c:pt>
                <c:pt idx="7">
                  <c:v>0.0320294784580499</c:v>
                </c:pt>
                <c:pt idx="8">
                  <c:v>0.0196995464852608</c:v>
                </c:pt>
                <c:pt idx="9">
                  <c:v>0.018140589569161</c:v>
                </c:pt>
                <c:pt idx="10">
                  <c:v>0.00581065759637188</c:v>
                </c:pt>
                <c:pt idx="11">
                  <c:v>0.000992063492063493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0871496"/>
        <c:axId val="2137633368"/>
      </c:barChart>
      <c:catAx>
        <c:axId val="-206087149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2137633368"/>
        <c:crosses val="autoZero"/>
        <c:auto val="1"/>
        <c:lblAlgn val="ctr"/>
        <c:lblOffset val="100"/>
        <c:noMultiLvlLbl val="0"/>
      </c:catAx>
      <c:valAx>
        <c:axId val="2137633368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0871496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306666666666667</c:v>
                </c:pt>
                <c:pt idx="4">
                  <c:v>0.493333333333333</c:v>
                </c:pt>
                <c:pt idx="5">
                  <c:v>0.2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0333333333333333</c:v>
                </c:pt>
                <c:pt idx="1">
                  <c:v>0.08</c:v>
                </c:pt>
                <c:pt idx="2">
                  <c:v>0.0533333333333334</c:v>
                </c:pt>
                <c:pt idx="3">
                  <c:v>0.28</c:v>
                </c:pt>
                <c:pt idx="4">
                  <c:v>0.306666666666667</c:v>
                </c:pt>
                <c:pt idx="5">
                  <c:v>0.08</c:v>
                </c:pt>
                <c:pt idx="6">
                  <c:v>0.0933333333333334</c:v>
                </c:pt>
                <c:pt idx="7">
                  <c:v>0.0666666666666667</c:v>
                </c:pt>
                <c:pt idx="8">
                  <c:v>0.00666666666666667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0685714285714286</c:v>
                </c:pt>
                <c:pt idx="1">
                  <c:v>0.394285714285715</c:v>
                </c:pt>
                <c:pt idx="2">
                  <c:v>0.228571428571429</c:v>
                </c:pt>
                <c:pt idx="3">
                  <c:v>0.0457142857142857</c:v>
                </c:pt>
                <c:pt idx="4">
                  <c:v>0.08</c:v>
                </c:pt>
                <c:pt idx="5">
                  <c:v>0.04</c:v>
                </c:pt>
                <c:pt idx="6">
                  <c:v>0.0</c:v>
                </c:pt>
                <c:pt idx="7">
                  <c:v>0.0628571428571429</c:v>
                </c:pt>
                <c:pt idx="8">
                  <c:v>0.0571428571428571</c:v>
                </c:pt>
                <c:pt idx="9">
                  <c:v>0.0228571428571429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1935880"/>
        <c:axId val="-1995026216"/>
      </c:barChart>
      <c:catAx>
        <c:axId val="-20619358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1995026216"/>
        <c:crosses val="autoZero"/>
        <c:auto val="1"/>
        <c:lblAlgn val="ctr"/>
        <c:lblOffset val="100"/>
        <c:noMultiLvlLbl val="0"/>
      </c:catAx>
      <c:valAx>
        <c:axId val="-1995026216"/>
        <c:scaling>
          <c:orientation val="minMax"/>
          <c:max val="0.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1935880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375</c:v>
                </c:pt>
                <c:pt idx="4">
                  <c:v>0.291666666666667</c:v>
                </c:pt>
                <c:pt idx="5">
                  <c:v>0.333333333333333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94574632"/>
        <c:axId val="-1995156136"/>
      </c:barChart>
      <c:catAx>
        <c:axId val="-19945746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1995156136"/>
        <c:crosses val="autoZero"/>
        <c:auto val="1"/>
        <c:lblAlgn val="ctr"/>
        <c:lblOffset val="100"/>
        <c:noMultiLvlLbl val="0"/>
      </c:catAx>
      <c:valAx>
        <c:axId val="-1995156136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199457463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0723809523809524</c:v>
                </c:pt>
                <c:pt idx="1">
                  <c:v>0.210476190476191</c:v>
                </c:pt>
                <c:pt idx="2">
                  <c:v>0.238095238095238</c:v>
                </c:pt>
                <c:pt idx="3">
                  <c:v>0.135238095238095</c:v>
                </c:pt>
                <c:pt idx="4">
                  <c:v>0.138095238095238</c:v>
                </c:pt>
                <c:pt idx="5">
                  <c:v>0.101904761904762</c:v>
                </c:pt>
                <c:pt idx="6">
                  <c:v>0.0666666666666667</c:v>
                </c:pt>
                <c:pt idx="7">
                  <c:v>0.0285714285714286</c:v>
                </c:pt>
                <c:pt idx="8">
                  <c:v>0.00857142857142857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123076923076923</c:v>
                </c:pt>
                <c:pt idx="1">
                  <c:v>0.277948717948718</c:v>
                </c:pt>
                <c:pt idx="2">
                  <c:v>0.140512820512821</c:v>
                </c:pt>
                <c:pt idx="3">
                  <c:v>0.18974358974359</c:v>
                </c:pt>
                <c:pt idx="4">
                  <c:v>0.164615384615385</c:v>
                </c:pt>
                <c:pt idx="5">
                  <c:v>0.0528205128205128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0205128205128205</c:v>
                </c:pt>
                <c:pt idx="11">
                  <c:v>0.0287179487179487</c:v>
                </c:pt>
                <c:pt idx="12">
                  <c:v>0.0205128205128205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110786516853933</c:v>
                </c:pt>
                <c:pt idx="1">
                  <c:v>0.290337078651685</c:v>
                </c:pt>
                <c:pt idx="2">
                  <c:v>0.239550561797753</c:v>
                </c:pt>
                <c:pt idx="3">
                  <c:v>0.139550561797753</c:v>
                </c:pt>
                <c:pt idx="4">
                  <c:v>0.0934831460674157</c:v>
                </c:pt>
                <c:pt idx="5">
                  <c:v>0.0435955056179775</c:v>
                </c:pt>
                <c:pt idx="6">
                  <c:v>0.0269662921348314</c:v>
                </c:pt>
                <c:pt idx="7">
                  <c:v>0.0141573033707865</c:v>
                </c:pt>
                <c:pt idx="8">
                  <c:v>0.00224719101123596</c:v>
                </c:pt>
                <c:pt idx="9">
                  <c:v>0.0</c:v>
                </c:pt>
                <c:pt idx="10">
                  <c:v>0.00292134831460674</c:v>
                </c:pt>
                <c:pt idx="11">
                  <c:v>0.0220224719101124</c:v>
                </c:pt>
                <c:pt idx="12">
                  <c:v>0.0123595505617978</c:v>
                </c:pt>
                <c:pt idx="13">
                  <c:v>0.002022471910112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94503144"/>
        <c:axId val="-2078494968"/>
      </c:barChart>
      <c:catAx>
        <c:axId val="-199450314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78494968"/>
        <c:crosses val="autoZero"/>
        <c:auto val="1"/>
        <c:lblAlgn val="ctr"/>
        <c:lblOffset val="100"/>
        <c:noMultiLvlLbl val="0"/>
      </c:catAx>
      <c:valAx>
        <c:axId val="-2078494968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1994503144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180147058823529</c:v>
                </c:pt>
                <c:pt idx="1">
                  <c:v>0.3125</c:v>
                </c:pt>
                <c:pt idx="2">
                  <c:v>0.181985294117647</c:v>
                </c:pt>
                <c:pt idx="3">
                  <c:v>0.170955882352941</c:v>
                </c:pt>
                <c:pt idx="4">
                  <c:v>0.0833333333333333</c:v>
                </c:pt>
                <c:pt idx="5">
                  <c:v>0.0575980392156863</c:v>
                </c:pt>
                <c:pt idx="6">
                  <c:v>0.0134803921568627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128205128205128</c:v>
                </c:pt>
                <c:pt idx="1">
                  <c:v>0.341346153846154</c:v>
                </c:pt>
                <c:pt idx="2">
                  <c:v>0.259615384615385</c:v>
                </c:pt>
                <c:pt idx="3">
                  <c:v>0.157051282051282</c:v>
                </c:pt>
                <c:pt idx="4">
                  <c:v>0.0721153846153846</c:v>
                </c:pt>
                <c:pt idx="5">
                  <c:v>0.0256410256410257</c:v>
                </c:pt>
                <c:pt idx="6">
                  <c:v>0.016025641025641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0891666666666668</c:v>
                </c:pt>
                <c:pt idx="1">
                  <c:v>0.295833333333333</c:v>
                </c:pt>
                <c:pt idx="2">
                  <c:v>0.262083333333333</c:v>
                </c:pt>
                <c:pt idx="3">
                  <c:v>0.134166666666667</c:v>
                </c:pt>
                <c:pt idx="4">
                  <c:v>0.105416666666667</c:v>
                </c:pt>
                <c:pt idx="5">
                  <c:v>0.0516666666666667</c:v>
                </c:pt>
                <c:pt idx="6">
                  <c:v>0.0325</c:v>
                </c:pt>
                <c:pt idx="7">
                  <c:v>0.0133333333333333</c:v>
                </c:pt>
                <c:pt idx="8">
                  <c:v>0.00875</c:v>
                </c:pt>
                <c:pt idx="9">
                  <c:v>0.00708333333333334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94618056"/>
        <c:axId val="-2061780440"/>
      </c:barChart>
      <c:catAx>
        <c:axId val="-199461805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1780440"/>
        <c:crosses val="autoZero"/>
        <c:auto val="1"/>
        <c:lblAlgn val="ctr"/>
        <c:lblOffset val="100"/>
        <c:noMultiLvlLbl val="0"/>
      </c:catAx>
      <c:valAx>
        <c:axId val="-2061780440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-1994618056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positive-RBS</c:v>
                </c:pt>
              </c:strCache>
            </c:strRef>
          </c:tx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19:$B$32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19:$C$32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52</c:v>
                </c:pt>
                <c:pt idx="4">
                  <c:v>0.48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8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19:$D$32</c:f>
              <c:numCache>
                <c:formatCode>General</c:formatCode>
                <c:ptCount val="14"/>
                <c:pt idx="0">
                  <c:v>0.133333333333333</c:v>
                </c:pt>
                <c:pt idx="1">
                  <c:v>0.262222222222222</c:v>
                </c:pt>
                <c:pt idx="2">
                  <c:v>0.186666666666667</c:v>
                </c:pt>
                <c:pt idx="3">
                  <c:v>0.137777777777778</c:v>
                </c:pt>
                <c:pt idx="4">
                  <c:v>0.04</c:v>
                </c:pt>
                <c:pt idx="5">
                  <c:v>0.0177777777777778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133333333333333</c:v>
                </c:pt>
                <c:pt idx="12">
                  <c:v>0.0666666666666667</c:v>
                </c:pt>
                <c:pt idx="13">
                  <c:v>0.02222222222222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7935032"/>
        <c:axId val="-2076445976"/>
      </c:barChart>
      <c:catAx>
        <c:axId val="21379350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76445976"/>
        <c:crosses val="autoZero"/>
        <c:auto val="1"/>
        <c:lblAlgn val="ctr"/>
        <c:lblOffset val="100"/>
        <c:noMultiLvlLbl val="0"/>
      </c:catAx>
      <c:valAx>
        <c:axId val="-20764459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21379350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111111111111111</c:v>
                </c:pt>
                <c:pt idx="1">
                  <c:v>0.361111111111111</c:v>
                </c:pt>
                <c:pt idx="2">
                  <c:v>0.194444444444445</c:v>
                </c:pt>
                <c:pt idx="3">
                  <c:v>0.0</c:v>
                </c:pt>
                <c:pt idx="4">
                  <c:v>0.125</c:v>
                </c:pt>
                <c:pt idx="5">
                  <c:v>0.0972222222222222</c:v>
                </c:pt>
                <c:pt idx="6">
                  <c:v>0.111111111111111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0625</c:v>
                </c:pt>
                <c:pt idx="1">
                  <c:v>0.395833333333333</c:v>
                </c:pt>
                <c:pt idx="2">
                  <c:v>0.0416666666666667</c:v>
                </c:pt>
                <c:pt idx="3">
                  <c:v>0.0</c:v>
                </c:pt>
                <c:pt idx="4">
                  <c:v>0.0</c:v>
                </c:pt>
                <c:pt idx="5">
                  <c:v>0.104166666666667</c:v>
                </c:pt>
                <c:pt idx="6">
                  <c:v>0.1875</c:v>
                </c:pt>
                <c:pt idx="7">
                  <c:v>0.208333333333333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0623800"/>
        <c:axId val="-2075414392"/>
      </c:barChart>
      <c:catAx>
        <c:axId val="-20606238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75414392"/>
        <c:crosses val="autoZero"/>
        <c:auto val="1"/>
        <c:lblAlgn val="ctr"/>
        <c:lblOffset val="100"/>
        <c:noMultiLvlLbl val="0"/>
      </c:catAx>
      <c:valAx>
        <c:axId val="-2075414392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0623800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19:$B$32</c:f>
              <c:numCache>
                <c:formatCode>General</c:formatCode>
                <c:ptCount val="14"/>
                <c:pt idx="0">
                  <c:v>0.0375</c:v>
                </c:pt>
                <c:pt idx="1">
                  <c:v>0.26</c:v>
                </c:pt>
                <c:pt idx="2">
                  <c:v>0.115</c:v>
                </c:pt>
                <c:pt idx="3">
                  <c:v>0.1025</c:v>
                </c:pt>
                <c:pt idx="4">
                  <c:v>0.1675</c:v>
                </c:pt>
                <c:pt idx="5">
                  <c:v>0.1125</c:v>
                </c:pt>
                <c:pt idx="6">
                  <c:v>0.055</c:v>
                </c:pt>
                <c:pt idx="7">
                  <c:v>0.025</c:v>
                </c:pt>
                <c:pt idx="8">
                  <c:v>0.0</c:v>
                </c:pt>
                <c:pt idx="9">
                  <c:v>0.0</c:v>
                </c:pt>
                <c:pt idx="10">
                  <c:v>0.0325</c:v>
                </c:pt>
                <c:pt idx="11">
                  <c:v>0.0575</c:v>
                </c:pt>
                <c:pt idx="12">
                  <c:v>0.035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19:$C$32</c:f>
              <c:numCache>
                <c:formatCode>General</c:formatCode>
                <c:ptCount val="14"/>
                <c:pt idx="0">
                  <c:v>0.126153846153846</c:v>
                </c:pt>
                <c:pt idx="1">
                  <c:v>0.215384615384615</c:v>
                </c:pt>
                <c:pt idx="2">
                  <c:v>0.150769230769231</c:v>
                </c:pt>
                <c:pt idx="3">
                  <c:v>0.224615384615385</c:v>
                </c:pt>
                <c:pt idx="4">
                  <c:v>0.196923076923077</c:v>
                </c:pt>
                <c:pt idx="5">
                  <c:v>0.0861538461538463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8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19:$A$32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19:$D$32</c:f>
              <c:numCache>
                <c:formatCode>General</c:formatCode>
                <c:ptCount val="14"/>
                <c:pt idx="0">
                  <c:v>0.118709677419355</c:v>
                </c:pt>
                <c:pt idx="1">
                  <c:v>0.321290322580645</c:v>
                </c:pt>
                <c:pt idx="2">
                  <c:v>0.233548387096774</c:v>
                </c:pt>
                <c:pt idx="3">
                  <c:v>0.139354838709677</c:v>
                </c:pt>
                <c:pt idx="4">
                  <c:v>0.087741935483871</c:v>
                </c:pt>
                <c:pt idx="5">
                  <c:v>0.0541935483870968</c:v>
                </c:pt>
                <c:pt idx="6">
                  <c:v>0.0322580645161291</c:v>
                </c:pt>
                <c:pt idx="7">
                  <c:v>0.0116129032258065</c:v>
                </c:pt>
                <c:pt idx="8">
                  <c:v>0.00129032258064516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4575752"/>
        <c:axId val="-2077119464"/>
      </c:barChart>
      <c:catAx>
        <c:axId val="20645757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77119464"/>
        <c:crosses val="autoZero"/>
        <c:auto val="1"/>
        <c:lblAlgn val="ctr"/>
        <c:lblOffset val="100"/>
        <c:noMultiLvlLbl val="0"/>
      </c:catAx>
      <c:valAx>
        <c:axId val="-2077119464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206457575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9</c:f>
              <c:strCache>
                <c:ptCount val="1"/>
                <c:pt idx="0">
                  <c:v>positive-RB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B$20:$B$33</c:f>
              <c:numCache>
                <c:formatCode>General</c:formatCode>
                <c:ptCount val="14"/>
                <c:pt idx="0">
                  <c:v>0.168859649122807</c:v>
                </c:pt>
                <c:pt idx="1">
                  <c:v>0.302631578947368</c:v>
                </c:pt>
                <c:pt idx="2">
                  <c:v>0.280701754385965</c:v>
                </c:pt>
                <c:pt idx="3">
                  <c:v>0.125</c:v>
                </c:pt>
                <c:pt idx="4">
                  <c:v>0.0657894736842105</c:v>
                </c:pt>
                <c:pt idx="5">
                  <c:v>0.0570175438596492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C$19</c:f>
              <c:strCache>
                <c:ptCount val="1"/>
                <c:pt idx="0">
                  <c:v>negative-neutral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C$20:$C$33</c:f>
              <c:numCache>
                <c:formatCode>General</c:formatCode>
                <c:ptCount val="14"/>
                <c:pt idx="0">
                  <c:v>0.109375</c:v>
                </c:pt>
                <c:pt idx="1">
                  <c:v>0.161458333333333</c:v>
                </c:pt>
                <c:pt idx="2">
                  <c:v>0.145833333333333</c:v>
                </c:pt>
                <c:pt idx="3">
                  <c:v>0.270833333333333</c:v>
                </c:pt>
                <c:pt idx="4">
                  <c:v>0.130208333333333</c:v>
                </c:pt>
                <c:pt idx="5">
                  <c:v>0.0364583333333333</c:v>
                </c:pt>
                <c:pt idx="6">
                  <c:v>0.0677083333333334</c:v>
                </c:pt>
                <c:pt idx="7">
                  <c:v>0.0364583333333333</c:v>
                </c:pt>
                <c:pt idx="8">
                  <c:v>0.0416666666666667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1!$D$19</c:f>
              <c:strCache>
                <c:ptCount val="1"/>
                <c:pt idx="0">
                  <c:v>neutral-RBS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cat>
            <c:strRef>
              <c:f>Sheet1!$A$20:$A$33</c:f>
              <c:strCache>
                <c:ptCount val="14"/>
                <c:pt idx="0">
                  <c:v>0-10</c:v>
                </c:pt>
                <c:pt idx="1">
                  <c:v>11-20</c:v>
                </c:pt>
                <c:pt idx="2">
                  <c:v>21-30</c:v>
                </c:pt>
                <c:pt idx="3">
                  <c:v>31-40</c:v>
                </c:pt>
                <c:pt idx="4">
                  <c:v>41-50</c:v>
                </c:pt>
                <c:pt idx="5">
                  <c:v>51-60</c:v>
                </c:pt>
                <c:pt idx="6">
                  <c:v>61-70</c:v>
                </c:pt>
                <c:pt idx="7">
                  <c:v>71-80</c:v>
                </c:pt>
                <c:pt idx="8">
                  <c:v>81-90</c:v>
                </c:pt>
                <c:pt idx="9">
                  <c:v>91-100</c:v>
                </c:pt>
                <c:pt idx="10">
                  <c:v>101-110</c:v>
                </c:pt>
                <c:pt idx="11">
                  <c:v>111-120</c:v>
                </c:pt>
                <c:pt idx="12">
                  <c:v>121-130</c:v>
                </c:pt>
                <c:pt idx="13">
                  <c:v>131-140</c:v>
                </c:pt>
              </c:strCache>
            </c:strRef>
          </c:cat>
          <c:val>
            <c:numRef>
              <c:f>Sheet1!$D$20:$D$33</c:f>
              <c:numCache>
                <c:formatCode>General</c:formatCode>
                <c:ptCount val="14"/>
                <c:pt idx="0">
                  <c:v>0.0662393162393163</c:v>
                </c:pt>
                <c:pt idx="1">
                  <c:v>0.186965811965812</c:v>
                </c:pt>
                <c:pt idx="2">
                  <c:v>0.240384615384615</c:v>
                </c:pt>
                <c:pt idx="3">
                  <c:v>0.161324786324786</c:v>
                </c:pt>
                <c:pt idx="4">
                  <c:v>0.108974358974359</c:v>
                </c:pt>
                <c:pt idx="5">
                  <c:v>0.0715811965811966</c:v>
                </c:pt>
                <c:pt idx="6">
                  <c:v>0.0662393162393163</c:v>
                </c:pt>
                <c:pt idx="7">
                  <c:v>0.0416666666666667</c:v>
                </c:pt>
                <c:pt idx="8">
                  <c:v>0.0416666666666667</c:v>
                </c:pt>
                <c:pt idx="9">
                  <c:v>0.00747863247863248</c:v>
                </c:pt>
                <c:pt idx="10">
                  <c:v>0.00747863247863248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1241080"/>
        <c:axId val="2137909672"/>
      </c:barChart>
      <c:catAx>
        <c:axId val="-20612410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 rot="-3000000"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2137909672"/>
        <c:crosses val="autoZero"/>
        <c:auto val="1"/>
        <c:lblAlgn val="ctr"/>
        <c:lblOffset val="100"/>
        <c:noMultiLvlLbl val="0"/>
      </c:catAx>
      <c:valAx>
        <c:axId val="2137909672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/>
                <a:cs typeface="Arial"/>
              </a:defRPr>
            </a:pPr>
            <a:endParaRPr lang="en-US"/>
          </a:p>
        </c:txPr>
        <c:crossAx val="-2061241080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E55E8A-D086-AC44-B5D0-B078DC46AFEA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A65EF3-3885-1E4B-90CD-274B74A2E27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9869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A65EF3-3885-1E4B-90CD-274B74A2E27D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0213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A65EF3-3885-1E4B-90CD-274B74A2E27D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0213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/06/20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5" Type="http://schemas.openxmlformats.org/officeDocument/2006/relationships/chart" Target="../charts/chart8.xml"/><Relationship Id="rId6" Type="http://schemas.openxmlformats.org/officeDocument/2006/relationships/chart" Target="../charts/chart9.xml"/><Relationship Id="rId7" Type="http://schemas.openxmlformats.org/officeDocument/2006/relationships/chart" Target="../charts/chart10.xml"/><Relationship Id="rId8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-1774436" y="269623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grpSp>
        <p:nvGrpSpPr>
          <p:cNvPr id="80" name="グループ化 79"/>
          <p:cNvGrpSpPr/>
          <p:nvPr/>
        </p:nvGrpSpPr>
        <p:grpSpPr>
          <a:xfrm>
            <a:off x="-58056" y="332656"/>
            <a:ext cx="9282110" cy="6227158"/>
            <a:chOff x="-58056" y="332656"/>
            <a:chExt cx="9282110" cy="6227158"/>
          </a:xfrm>
        </p:grpSpPr>
        <p:grpSp>
          <p:nvGrpSpPr>
            <p:cNvPr id="61" name="グループ化 60"/>
            <p:cNvGrpSpPr/>
            <p:nvPr/>
          </p:nvGrpSpPr>
          <p:grpSpPr>
            <a:xfrm>
              <a:off x="3302349" y="1187820"/>
              <a:ext cx="3170887" cy="3993178"/>
              <a:chOff x="2985289" y="1173306"/>
              <a:chExt cx="3170887" cy="3993178"/>
            </a:xfrm>
          </p:grpSpPr>
          <p:graphicFrame>
            <p:nvGraphicFramePr>
              <p:cNvPr id="40" name="グラフ 39"/>
              <p:cNvGraphicFramePr/>
              <p:nvPr>
                <p:extLst>
                  <p:ext uri="{D42A27DB-BD31-4B8C-83A1-F6EECF244321}">
                    <p14:modId xmlns:p14="http://schemas.microsoft.com/office/powerpoint/2010/main" val="367480419"/>
                  </p:ext>
                </p:extLst>
              </p:nvPr>
            </p:nvGraphicFramePr>
            <p:xfrm>
              <a:off x="3131840" y="1412776"/>
              <a:ext cx="3024336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0" name="テキスト ボックス 9"/>
              <p:cNvSpPr txBox="1"/>
              <p:nvPr/>
            </p:nvSpPr>
            <p:spPr>
              <a:xfrm>
                <a:off x="3022993" y="1173306"/>
                <a:ext cx="287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/>
                    <a:cs typeface="Arial"/>
                  </a:rPr>
                  <a:t>B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>
                <a:off x="3033373" y="4041903"/>
                <a:ext cx="287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E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4067944" y="4797152"/>
                <a:ext cx="5849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/>
                  <a:t>N.A.</a:t>
                </a:r>
                <a:endParaRPr kumimoji="1" lang="ja-JP" altLang="en-US" dirty="0"/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>
                <a:off x="4147863" y="3271216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 rot="16200000">
                <a:off x="2734418" y="2031687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</p:grpSp>
        <p:grpSp>
          <p:nvGrpSpPr>
            <p:cNvPr id="64" name="グループ化 63"/>
            <p:cNvGrpSpPr/>
            <p:nvPr/>
          </p:nvGrpSpPr>
          <p:grpSpPr>
            <a:xfrm>
              <a:off x="548484" y="1207705"/>
              <a:ext cx="3000890" cy="5352109"/>
              <a:chOff x="130950" y="1178677"/>
              <a:chExt cx="3000890" cy="5352109"/>
            </a:xfrm>
          </p:grpSpPr>
          <p:graphicFrame>
            <p:nvGraphicFramePr>
              <p:cNvPr id="39" name="グラフ 38"/>
              <p:cNvGraphicFramePr/>
              <p:nvPr>
                <p:extLst>
                  <p:ext uri="{D42A27DB-BD31-4B8C-83A1-F6EECF244321}">
                    <p14:modId xmlns:p14="http://schemas.microsoft.com/office/powerpoint/2010/main" val="3102552871"/>
                  </p:ext>
                </p:extLst>
              </p:nvPr>
            </p:nvGraphicFramePr>
            <p:xfrm>
              <a:off x="323528" y="1412776"/>
              <a:ext cx="2808312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42" name="グラフ 41"/>
              <p:cNvGraphicFramePr/>
              <p:nvPr>
                <p:extLst>
                  <p:ext uri="{D42A27DB-BD31-4B8C-83A1-F6EECF244321}">
                    <p14:modId xmlns:p14="http://schemas.microsoft.com/office/powerpoint/2010/main" val="989196258"/>
                  </p:ext>
                </p:extLst>
              </p:nvPr>
            </p:nvGraphicFramePr>
            <p:xfrm>
              <a:off x="323528" y="4383502"/>
              <a:ext cx="2808312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9" name="テキスト ボックス 8"/>
              <p:cNvSpPr txBox="1"/>
              <p:nvPr/>
            </p:nvSpPr>
            <p:spPr>
              <a:xfrm>
                <a:off x="130950" y="1178677"/>
                <a:ext cx="3001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/>
                    <a:cs typeface="Arial"/>
                  </a:rPr>
                  <a:t>A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141330" y="4047274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/>
                    <a:cs typeface="Arial"/>
                  </a:rPr>
                  <a:t>D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7" name="テキスト ボックス 46"/>
              <p:cNvSpPr txBox="1"/>
              <p:nvPr/>
            </p:nvSpPr>
            <p:spPr>
              <a:xfrm>
                <a:off x="1255327" y="3283064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 rot="16200000">
                <a:off x="-91038" y="2024831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1194692" y="6269176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 rot="16200000">
                <a:off x="-91038" y="5036521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</p:grpSp>
        <p:grpSp>
          <p:nvGrpSpPr>
            <p:cNvPr id="46" name="グループ化 45"/>
            <p:cNvGrpSpPr/>
            <p:nvPr/>
          </p:nvGrpSpPr>
          <p:grpSpPr>
            <a:xfrm>
              <a:off x="6162879" y="1188730"/>
              <a:ext cx="3061175" cy="5330024"/>
              <a:chOff x="5903313" y="1188730"/>
              <a:chExt cx="3061175" cy="5330024"/>
            </a:xfrm>
          </p:grpSpPr>
          <p:graphicFrame>
            <p:nvGraphicFramePr>
              <p:cNvPr id="41" name="グラフ 40"/>
              <p:cNvGraphicFramePr/>
              <p:nvPr>
                <p:extLst>
                  <p:ext uri="{D42A27DB-BD31-4B8C-83A1-F6EECF244321}">
                    <p14:modId xmlns:p14="http://schemas.microsoft.com/office/powerpoint/2010/main" val="538775488"/>
                  </p:ext>
                </p:extLst>
              </p:nvPr>
            </p:nvGraphicFramePr>
            <p:xfrm>
              <a:off x="6156176" y="1412776"/>
              <a:ext cx="2808312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45" name="グラフ 44"/>
              <p:cNvGraphicFramePr/>
              <p:nvPr>
                <p:extLst>
                  <p:ext uri="{D42A27DB-BD31-4B8C-83A1-F6EECF244321}">
                    <p14:modId xmlns:p14="http://schemas.microsoft.com/office/powerpoint/2010/main" val="66495096"/>
                  </p:ext>
                </p:extLst>
              </p:nvPr>
            </p:nvGraphicFramePr>
            <p:xfrm>
              <a:off x="6156176" y="4383502"/>
              <a:ext cx="2808312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1" name="テキスト ボックス 10"/>
              <p:cNvSpPr txBox="1"/>
              <p:nvPr/>
            </p:nvSpPr>
            <p:spPr>
              <a:xfrm>
                <a:off x="5903313" y="1188730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>
                    <a:latin typeface="Arial"/>
                    <a:cs typeface="Arial"/>
                  </a:rPr>
                  <a:t>C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5913693" y="4057327"/>
                <a:ext cx="2786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 smtClean="0">
                    <a:latin typeface="Arial"/>
                    <a:cs typeface="Arial"/>
                  </a:rPr>
                  <a:t>F</a:t>
                </a:r>
                <a:endParaRPr kumimoji="1" lang="ja-JP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9" name="テキスト ボックス 48"/>
              <p:cNvSpPr txBox="1"/>
              <p:nvPr/>
            </p:nvSpPr>
            <p:spPr>
              <a:xfrm>
                <a:off x="7169058" y="3271032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 rot="16200000">
                <a:off x="5740086" y="2033653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  <p:sp>
            <p:nvSpPr>
              <p:cNvPr id="62" name="テキスト ボックス 61"/>
              <p:cNvSpPr txBox="1"/>
              <p:nvPr/>
            </p:nvSpPr>
            <p:spPr>
              <a:xfrm>
                <a:off x="7183572" y="6257144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 rot="16200000">
                <a:off x="5719680" y="5036521"/>
                <a:ext cx="80416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frequency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sp>
          <p:nvSpPr>
            <p:cNvPr id="66" name="テキスト ボックス 65"/>
            <p:cNvSpPr txBox="1"/>
            <p:nvPr/>
          </p:nvSpPr>
          <p:spPr>
            <a:xfrm>
              <a:off x="-58056" y="1930195"/>
              <a:ext cx="7576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A/H3N2</a:t>
              </a:r>
            </a:p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virus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-58056" y="4826180"/>
              <a:ext cx="7576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A/H1N1 </a:t>
              </a:r>
            </a:p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virus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1820620" y="967338"/>
              <a:ext cx="60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/>
                  <a:cs typeface="Arial"/>
                </a:rPr>
                <a:t>NGS+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4628932" y="967338"/>
              <a:ext cx="60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/>
                  <a:cs typeface="Arial"/>
                </a:rPr>
                <a:t>NGS−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7509252" y="967338"/>
              <a:ext cx="6025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/>
                  <a:cs typeface="Arial"/>
                </a:rPr>
                <a:t>NGS±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grpSp>
          <p:nvGrpSpPr>
            <p:cNvPr id="71" name="グループ化 40"/>
            <p:cNvGrpSpPr/>
            <p:nvPr/>
          </p:nvGrpSpPr>
          <p:grpSpPr>
            <a:xfrm>
              <a:off x="5950526" y="332656"/>
              <a:ext cx="784326" cy="261610"/>
              <a:chOff x="7827436" y="3797133"/>
              <a:chExt cx="784326" cy="261610"/>
            </a:xfrm>
          </p:grpSpPr>
          <p:sp>
            <p:nvSpPr>
              <p:cNvPr id="72" name="正方形/長方形 71"/>
              <p:cNvSpPr/>
              <p:nvPr/>
            </p:nvSpPr>
            <p:spPr>
              <a:xfrm>
                <a:off x="7827436" y="3868579"/>
                <a:ext cx="144016" cy="14401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73" name="テキスト ボックス 72"/>
              <p:cNvSpPr txBox="1"/>
              <p:nvPr/>
            </p:nvSpPr>
            <p:spPr>
              <a:xfrm>
                <a:off x="7913396" y="3797133"/>
                <a:ext cx="6983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charge+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74" name="グループ化 41"/>
            <p:cNvGrpSpPr/>
            <p:nvPr/>
          </p:nvGrpSpPr>
          <p:grpSpPr>
            <a:xfrm>
              <a:off x="6708706" y="332656"/>
              <a:ext cx="783764" cy="261610"/>
              <a:chOff x="7827436" y="4007589"/>
              <a:chExt cx="783764" cy="261610"/>
            </a:xfrm>
          </p:grpSpPr>
          <p:sp>
            <p:nvSpPr>
              <p:cNvPr id="75" name="正方形/長方形 74"/>
              <p:cNvSpPr/>
              <p:nvPr/>
            </p:nvSpPr>
            <p:spPr>
              <a:xfrm>
                <a:off x="7827436" y="4084603"/>
                <a:ext cx="144016" cy="144016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76" name="テキスト ボックス 75"/>
              <p:cNvSpPr txBox="1"/>
              <p:nvPr/>
            </p:nvSpPr>
            <p:spPr>
              <a:xfrm>
                <a:off x="7912834" y="4007589"/>
                <a:ext cx="6983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charge−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77" name="グループ化 39"/>
            <p:cNvGrpSpPr/>
            <p:nvPr/>
          </p:nvGrpSpPr>
          <p:grpSpPr>
            <a:xfrm>
              <a:off x="7499533" y="332656"/>
              <a:ext cx="798014" cy="261610"/>
              <a:chOff x="7827600" y="3580636"/>
              <a:chExt cx="798014" cy="261610"/>
            </a:xfrm>
          </p:grpSpPr>
          <p:sp>
            <p:nvSpPr>
              <p:cNvPr id="78" name="正方形/長方形 77"/>
              <p:cNvSpPr/>
              <p:nvPr/>
            </p:nvSpPr>
            <p:spPr>
              <a:xfrm>
                <a:off x="7827600" y="3652082"/>
                <a:ext cx="144016" cy="14401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79" name="テキスト ボックス 78"/>
              <p:cNvSpPr txBox="1"/>
              <p:nvPr/>
            </p:nvSpPr>
            <p:spPr>
              <a:xfrm>
                <a:off x="7913560" y="3580636"/>
                <a:ext cx="71205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charge±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-1774436" y="269623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grpSp>
        <p:nvGrpSpPr>
          <p:cNvPr id="70" name="グループ化 69"/>
          <p:cNvGrpSpPr/>
          <p:nvPr/>
        </p:nvGrpSpPr>
        <p:grpSpPr>
          <a:xfrm>
            <a:off x="-43542" y="332656"/>
            <a:ext cx="9267596" cy="6217180"/>
            <a:chOff x="-43542" y="332656"/>
            <a:chExt cx="9267596" cy="6217180"/>
          </a:xfrm>
        </p:grpSpPr>
        <p:grpSp>
          <p:nvGrpSpPr>
            <p:cNvPr id="48" name="グループ化 47"/>
            <p:cNvGrpSpPr/>
            <p:nvPr/>
          </p:nvGrpSpPr>
          <p:grpSpPr>
            <a:xfrm>
              <a:off x="463100" y="1193191"/>
              <a:ext cx="3129254" cy="5356645"/>
              <a:chOff x="130950" y="1178677"/>
              <a:chExt cx="3129254" cy="5356645"/>
            </a:xfrm>
          </p:grpSpPr>
          <p:graphicFrame>
            <p:nvGraphicFramePr>
              <p:cNvPr id="39" name="グラフ 38"/>
              <p:cNvGraphicFramePr/>
              <p:nvPr>
                <p:extLst>
                  <p:ext uri="{D42A27DB-BD31-4B8C-83A1-F6EECF244321}">
                    <p14:modId xmlns:p14="http://schemas.microsoft.com/office/powerpoint/2010/main" val="2766844666"/>
                  </p:ext>
                </p:extLst>
              </p:nvPr>
            </p:nvGraphicFramePr>
            <p:xfrm>
              <a:off x="413792" y="1412776"/>
              <a:ext cx="2808312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42" name="グラフ 41"/>
              <p:cNvGraphicFramePr/>
              <p:nvPr>
                <p:extLst>
                  <p:ext uri="{D42A27DB-BD31-4B8C-83A1-F6EECF244321}">
                    <p14:modId xmlns:p14="http://schemas.microsoft.com/office/powerpoint/2010/main" val="3692714617"/>
                  </p:ext>
                </p:extLst>
              </p:nvPr>
            </p:nvGraphicFramePr>
            <p:xfrm>
              <a:off x="413792" y="4365104"/>
              <a:ext cx="2846412" cy="210728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9" name="テキスト ボックス 8"/>
              <p:cNvSpPr txBox="1"/>
              <p:nvPr/>
            </p:nvSpPr>
            <p:spPr>
              <a:xfrm>
                <a:off x="130950" y="1178677"/>
                <a:ext cx="32431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G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141330" y="4047274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J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1426556" y="3268550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1380435" y="6273712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 rot="16200000">
                <a:off x="7473" y="2014603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 rot="16200000">
                <a:off x="7473" y="4997490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</p:grpSp>
        <p:grpSp>
          <p:nvGrpSpPr>
            <p:cNvPr id="47" name="グループ化 46"/>
            <p:cNvGrpSpPr/>
            <p:nvPr/>
          </p:nvGrpSpPr>
          <p:grpSpPr>
            <a:xfrm>
              <a:off x="3355143" y="1187820"/>
              <a:ext cx="3117531" cy="5350168"/>
              <a:chOff x="3022993" y="1173306"/>
              <a:chExt cx="3117531" cy="5350168"/>
            </a:xfrm>
          </p:grpSpPr>
          <p:graphicFrame>
            <p:nvGraphicFramePr>
              <p:cNvPr id="40" name="グラフ 39"/>
              <p:cNvGraphicFramePr/>
              <p:nvPr>
                <p:extLst>
                  <p:ext uri="{D42A27DB-BD31-4B8C-83A1-F6EECF244321}">
                    <p14:modId xmlns:p14="http://schemas.microsoft.com/office/powerpoint/2010/main" val="4248012070"/>
                  </p:ext>
                </p:extLst>
              </p:nvPr>
            </p:nvGraphicFramePr>
            <p:xfrm>
              <a:off x="3260204" y="1412776"/>
              <a:ext cx="2808312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43" name="グラフ 42"/>
              <p:cNvGraphicFramePr/>
              <p:nvPr>
                <p:extLst>
                  <p:ext uri="{D42A27DB-BD31-4B8C-83A1-F6EECF244321}">
                    <p14:modId xmlns:p14="http://schemas.microsoft.com/office/powerpoint/2010/main" val="2872546425"/>
                  </p:ext>
                </p:extLst>
              </p:nvPr>
            </p:nvGraphicFramePr>
            <p:xfrm>
              <a:off x="3260204" y="4365104"/>
              <a:ext cx="2880320" cy="20882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0" name="テキスト ボックス 9"/>
              <p:cNvSpPr txBox="1"/>
              <p:nvPr/>
            </p:nvSpPr>
            <p:spPr>
              <a:xfrm>
                <a:off x="3022993" y="1173306"/>
                <a:ext cx="3143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/>
                    <a:cs typeface="Arial"/>
                  </a:rPr>
                  <a:t>H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>
                <a:off x="3033373" y="4041903"/>
                <a:ext cx="30441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K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4280873" y="3256702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4234752" y="6261864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 rot="16200000">
                <a:off x="2858126" y="2014603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 rot="16200000">
                <a:off x="2858126" y="5007138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</p:grpSp>
        <p:grpSp>
          <p:nvGrpSpPr>
            <p:cNvPr id="46" name="グループ化 45"/>
            <p:cNvGrpSpPr/>
            <p:nvPr/>
          </p:nvGrpSpPr>
          <p:grpSpPr>
            <a:xfrm>
              <a:off x="6090871" y="1188730"/>
              <a:ext cx="3133183" cy="5334560"/>
              <a:chOff x="5903313" y="1188730"/>
              <a:chExt cx="3133183" cy="5334560"/>
            </a:xfrm>
          </p:grpSpPr>
          <p:graphicFrame>
            <p:nvGraphicFramePr>
              <p:cNvPr id="41" name="グラフ 40"/>
              <p:cNvGraphicFramePr/>
              <p:nvPr>
                <p:extLst>
                  <p:ext uri="{D42A27DB-BD31-4B8C-83A1-F6EECF244321}">
                    <p14:modId xmlns:p14="http://schemas.microsoft.com/office/powerpoint/2010/main" val="330504096"/>
                  </p:ext>
                </p:extLst>
              </p:nvPr>
            </p:nvGraphicFramePr>
            <p:xfrm>
              <a:off x="6174432" y="1412776"/>
              <a:ext cx="2862064" cy="20162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45" name="グラフ 44"/>
              <p:cNvGraphicFramePr/>
              <p:nvPr>
                <p:extLst>
                  <p:ext uri="{D42A27DB-BD31-4B8C-83A1-F6EECF244321}">
                    <p14:modId xmlns:p14="http://schemas.microsoft.com/office/powerpoint/2010/main" val="790632017"/>
                  </p:ext>
                </p:extLst>
              </p:nvPr>
            </p:nvGraphicFramePr>
            <p:xfrm>
              <a:off x="6136332" y="4365104"/>
              <a:ext cx="2900164" cy="20882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11" name="テキスト ボックス 10"/>
              <p:cNvSpPr txBox="1"/>
              <p:nvPr/>
            </p:nvSpPr>
            <p:spPr>
              <a:xfrm>
                <a:off x="5903313" y="1188730"/>
                <a:ext cx="23454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I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5913693" y="4057327"/>
                <a:ext cx="2872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 smtClean="0">
                    <a:latin typeface="Arial"/>
                    <a:cs typeface="Arial"/>
                  </a:rPr>
                  <a:t>L</a:t>
                </a:r>
                <a:endParaRPr kumimoji="1" lang="ja-JP" alt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7233201" y="3256518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7187080" y="6261680"/>
                <a:ext cx="9373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distance (Å)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 rot="16200000">
                <a:off x="5748991" y="2014603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 rot="16200000">
                <a:off x="5748991" y="4983074"/>
                <a:ext cx="7633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frequency</a:t>
                </a:r>
                <a:endParaRPr kumimoji="1" lang="ja-JP" altLang="en-US" sz="1100" dirty="0"/>
              </a:p>
            </p:txBody>
          </p:sp>
        </p:grpSp>
        <p:sp>
          <p:nvSpPr>
            <p:cNvPr id="49" name="テキスト ボックス 48"/>
            <p:cNvSpPr txBox="1"/>
            <p:nvPr/>
          </p:nvSpPr>
          <p:spPr>
            <a:xfrm>
              <a:off x="-43542" y="1930195"/>
              <a:ext cx="7576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A/H3N2</a:t>
              </a:r>
            </a:p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virus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-43542" y="4826180"/>
              <a:ext cx="7576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A/H1N1 </a:t>
              </a:r>
            </a:p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virus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1820620" y="967338"/>
              <a:ext cx="6785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 smtClean="0">
                  <a:latin typeface="Arial"/>
                  <a:cs typeface="Arial"/>
                </a:rPr>
                <a:t>NGS+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4628932" y="967338"/>
              <a:ext cx="6785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 smtClean="0">
                  <a:latin typeface="Arial"/>
                  <a:cs typeface="Arial"/>
                </a:rPr>
                <a:t>NGS−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7509252" y="967338"/>
              <a:ext cx="6815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 smtClean="0">
                  <a:latin typeface="Arial"/>
                  <a:cs typeface="Arial"/>
                </a:rPr>
                <a:t>NGS±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  <p:grpSp>
          <p:nvGrpSpPr>
            <p:cNvPr id="61" name="グループ化 40"/>
            <p:cNvGrpSpPr/>
            <p:nvPr/>
          </p:nvGrpSpPr>
          <p:grpSpPr>
            <a:xfrm>
              <a:off x="5950526" y="332656"/>
              <a:ext cx="784326" cy="261610"/>
              <a:chOff x="7827436" y="3797133"/>
              <a:chExt cx="784326" cy="261610"/>
            </a:xfrm>
          </p:grpSpPr>
          <p:sp>
            <p:nvSpPr>
              <p:cNvPr id="62" name="正方形/長方形 61"/>
              <p:cNvSpPr/>
              <p:nvPr/>
            </p:nvSpPr>
            <p:spPr>
              <a:xfrm>
                <a:off x="7827436" y="3868579"/>
                <a:ext cx="144016" cy="14401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7913396" y="3797133"/>
                <a:ext cx="6983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charge+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64" name="グループ化 41"/>
            <p:cNvGrpSpPr/>
            <p:nvPr/>
          </p:nvGrpSpPr>
          <p:grpSpPr>
            <a:xfrm>
              <a:off x="6708706" y="332656"/>
              <a:ext cx="783764" cy="261610"/>
              <a:chOff x="7827436" y="4007589"/>
              <a:chExt cx="783764" cy="261610"/>
            </a:xfrm>
          </p:grpSpPr>
          <p:sp>
            <p:nvSpPr>
              <p:cNvPr id="65" name="正方形/長方形 64"/>
              <p:cNvSpPr/>
              <p:nvPr/>
            </p:nvSpPr>
            <p:spPr>
              <a:xfrm>
                <a:off x="7827436" y="4084603"/>
                <a:ext cx="144016" cy="144016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>
                <a:off x="7912834" y="4007589"/>
                <a:ext cx="6983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charge−</a:t>
                </a:r>
                <a:r>
                  <a:rPr kumimoji="1" lang="en-US" altLang="ja-JP" sz="1100" dirty="0" smtClean="0">
                    <a:latin typeface="Arial"/>
                    <a:cs typeface="Arial"/>
                  </a:rPr>
                  <a:t> 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67" name="グループ化 39"/>
            <p:cNvGrpSpPr/>
            <p:nvPr/>
          </p:nvGrpSpPr>
          <p:grpSpPr>
            <a:xfrm>
              <a:off x="7499533" y="332656"/>
              <a:ext cx="798014" cy="261610"/>
              <a:chOff x="7827600" y="3580636"/>
              <a:chExt cx="798014" cy="261610"/>
            </a:xfrm>
          </p:grpSpPr>
          <p:sp>
            <p:nvSpPr>
              <p:cNvPr id="68" name="正方形/長方形 67"/>
              <p:cNvSpPr/>
              <p:nvPr/>
            </p:nvSpPr>
            <p:spPr>
              <a:xfrm>
                <a:off x="7827600" y="3652082"/>
                <a:ext cx="144016" cy="14401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>
                <a:off x="7913560" y="3580636"/>
                <a:ext cx="71205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>
                    <a:latin typeface="Arial"/>
                    <a:cs typeface="Arial"/>
                  </a:rPr>
                  <a:t>charge±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111</Words>
  <Application>Microsoft Macintosh PowerPoint</Application>
  <PresentationFormat>On-screen Show (4:3)</PresentationFormat>
  <Paragraphs>57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cp:lastModifiedBy>Yuki Suzuki</cp:lastModifiedBy>
  <cp:revision>120</cp:revision>
  <dcterms:modified xsi:type="dcterms:W3CDTF">2012-06-20T16:21:39Z</dcterms:modified>
</cp:coreProperties>
</file>